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97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33" d="100"/>
        <a:sy n="33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6451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7128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4502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197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9605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1267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7891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502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6081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3321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9852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9919D-0EE8-489B-BA97-4A526BD677E9}" type="datetimeFigureOut">
              <a:rPr lang="en-IN" smtClean="0"/>
              <a:t>02-06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B120F-E43A-4467-8B1D-4FA22E1BE5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6931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Relationship Id="rId9" Type="http://schemas.openxmlformats.org/officeDocument/2006/relationships/image" Target="../media/image16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g"/><Relationship Id="rId3" Type="http://schemas.openxmlformats.org/officeDocument/2006/relationships/image" Target="../media/image18.jpg"/><Relationship Id="rId7" Type="http://schemas.openxmlformats.org/officeDocument/2006/relationships/image" Target="../media/image22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4" Type="http://schemas.openxmlformats.org/officeDocument/2006/relationships/image" Target="../media/image19.jpg"/><Relationship Id="rId9" Type="http://schemas.openxmlformats.org/officeDocument/2006/relationships/image" Target="../media/image24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g"/><Relationship Id="rId3" Type="http://schemas.openxmlformats.org/officeDocument/2006/relationships/image" Target="../media/image26.jpg"/><Relationship Id="rId7" Type="http://schemas.openxmlformats.org/officeDocument/2006/relationships/image" Target="../media/image30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jpg"/><Relationship Id="rId5" Type="http://schemas.openxmlformats.org/officeDocument/2006/relationships/image" Target="../media/image28.jpg"/><Relationship Id="rId4" Type="http://schemas.openxmlformats.org/officeDocument/2006/relationships/image" Target="../media/image27.jpg"/><Relationship Id="rId9" Type="http://schemas.openxmlformats.org/officeDocument/2006/relationships/image" Target="../media/image32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g"/><Relationship Id="rId3" Type="http://schemas.openxmlformats.org/officeDocument/2006/relationships/image" Target="../media/image34.jpg"/><Relationship Id="rId7" Type="http://schemas.openxmlformats.org/officeDocument/2006/relationships/image" Target="../media/image38.jpg"/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jpg"/><Relationship Id="rId5" Type="http://schemas.openxmlformats.org/officeDocument/2006/relationships/image" Target="../media/image36.jpg"/><Relationship Id="rId4" Type="http://schemas.openxmlformats.org/officeDocument/2006/relationships/image" Target="../media/image35.jpg"/><Relationship Id="rId9" Type="http://schemas.openxmlformats.org/officeDocument/2006/relationships/image" Target="../media/image40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g"/><Relationship Id="rId3" Type="http://schemas.openxmlformats.org/officeDocument/2006/relationships/image" Target="../media/image42.jpg"/><Relationship Id="rId7" Type="http://schemas.openxmlformats.org/officeDocument/2006/relationships/image" Target="../media/image46.jpg"/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jpg"/><Relationship Id="rId5" Type="http://schemas.openxmlformats.org/officeDocument/2006/relationships/image" Target="../media/image44.jpg"/><Relationship Id="rId4" Type="http://schemas.openxmlformats.org/officeDocument/2006/relationships/image" Target="../media/image43.jpg"/><Relationship Id="rId9" Type="http://schemas.openxmlformats.org/officeDocument/2006/relationships/image" Target="../media/image4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C8E1275D-5AB8-A16C-2C53-8812C7CA60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033" y="1414077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line chart, scatter chart&#10;&#10;Description automatically generated">
            <a:extLst>
              <a:ext uri="{FF2B5EF4-FFF2-40B4-BE49-F238E27FC236}">
                <a16:creationId xmlns:a16="http://schemas.microsoft.com/office/drawing/2014/main" id="{F1A396B3-D629-BE3C-55FC-F755B97D30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7825" y="39090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E3C6A6B6-006A-8525-A296-230DDCD633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1549" y="39090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AB5A0306-E2EC-33C9-1993-02FEEA7450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033" y="39090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Chart, line chart&#10;&#10;Description automatically generated">
            <a:extLst>
              <a:ext uri="{FF2B5EF4-FFF2-40B4-BE49-F238E27FC236}">
                <a16:creationId xmlns:a16="http://schemas.microsoft.com/office/drawing/2014/main" id="{B7DA2F66-AC09-7421-4053-11F54457BDE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3969" y="1414077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Chart, line chart&#10;&#10;Description automatically generated">
            <a:extLst>
              <a:ext uri="{FF2B5EF4-FFF2-40B4-BE49-F238E27FC236}">
                <a16:creationId xmlns:a16="http://schemas.microsoft.com/office/drawing/2014/main" id="{12025769-152C-5466-1814-802C339E77A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7905" y="1414077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 descr="Chart, line chart&#10;&#10;Description automatically generated">
            <a:extLst>
              <a:ext uri="{FF2B5EF4-FFF2-40B4-BE49-F238E27FC236}">
                <a16:creationId xmlns:a16="http://schemas.microsoft.com/office/drawing/2014/main" id="{28553224-E681-3982-0F35-701128DC240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97" y="39090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Chart, line chart&#10;&#10;Description automatically generated">
            <a:extLst>
              <a:ext uri="{FF2B5EF4-FFF2-40B4-BE49-F238E27FC236}">
                <a16:creationId xmlns:a16="http://schemas.microsoft.com/office/drawing/2014/main" id="{DC626FFB-D040-52EC-461E-8F00CBE506A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97" y="1414077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itle 23">
            <a:extLst>
              <a:ext uri="{FF2B5EF4-FFF2-40B4-BE49-F238E27FC236}">
                <a16:creationId xmlns:a16="http://schemas.microsoft.com/office/drawing/2014/main" id="{6B947633-9FA8-A0CF-0974-A7E596D8B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997" y="456567"/>
            <a:ext cx="8557260" cy="72453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800" dirty="0"/>
              <a:t>Q-Q plots for days to heading based on SABWGPYT panels at Jabalpur</a:t>
            </a:r>
            <a:endParaRPr lang="en-IN" sz="2800" dirty="0"/>
          </a:p>
        </p:txBody>
      </p:sp>
    </p:spTree>
    <p:extLst>
      <p:ext uri="{BB962C8B-B14F-4D97-AF65-F5344CB8AC3E}">
        <p14:creationId xmlns:p14="http://schemas.microsoft.com/office/powerpoint/2010/main" val="848919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line chart, scatter chart&#10;&#10;Description automatically generated">
            <a:extLst>
              <a:ext uri="{FF2B5EF4-FFF2-40B4-BE49-F238E27FC236}">
                <a16:creationId xmlns:a16="http://schemas.microsoft.com/office/drawing/2014/main" id="{DF3174B3-9A18-06EB-F308-5DB88B232B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97" y="146304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, line chart&#10;&#10;Description automatically generated">
            <a:extLst>
              <a:ext uri="{FF2B5EF4-FFF2-40B4-BE49-F238E27FC236}">
                <a16:creationId xmlns:a16="http://schemas.microsoft.com/office/drawing/2014/main" id="{64ED5352-7A80-49A4-2FD9-073AF815F4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639" y="146304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5B1841B3-698C-C992-AAE0-3D9367072A2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2281" y="146304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line chart&#10;&#10;Description automatically generated">
            <a:extLst>
              <a:ext uri="{FF2B5EF4-FFF2-40B4-BE49-F238E27FC236}">
                <a16:creationId xmlns:a16="http://schemas.microsoft.com/office/drawing/2014/main" id="{9B2EE6A1-CC18-A007-810E-413369E6F5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3923" y="146304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849485F2-5868-50B3-FFF3-495374D38E0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97" y="37719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5B771159-8E71-0AF8-7F17-26AC5540C1C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639" y="37719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Chart, line chart&#10;&#10;Description automatically generated">
            <a:extLst>
              <a:ext uri="{FF2B5EF4-FFF2-40B4-BE49-F238E27FC236}">
                <a16:creationId xmlns:a16="http://schemas.microsoft.com/office/drawing/2014/main" id="{351437A2-CAAA-F0ED-F609-A80CB51E91C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2281" y="37719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Chart, line chart&#10;&#10;Description automatically generated">
            <a:extLst>
              <a:ext uri="{FF2B5EF4-FFF2-40B4-BE49-F238E27FC236}">
                <a16:creationId xmlns:a16="http://schemas.microsoft.com/office/drawing/2014/main" id="{B073F71C-A5FA-5C5C-D5DD-1F4C9BC949A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3923" y="37719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itle 23">
            <a:extLst>
              <a:ext uri="{FF2B5EF4-FFF2-40B4-BE49-F238E27FC236}">
                <a16:creationId xmlns:a16="http://schemas.microsoft.com/office/drawing/2014/main" id="{C869A501-D343-20EC-0834-A8BD9A73F9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997" y="456567"/>
            <a:ext cx="8557260" cy="72453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800" dirty="0"/>
              <a:t>Q-Q plots for days to heading based on SABWGPYT panels at Ludhiana</a:t>
            </a:r>
            <a:endParaRPr lang="en-IN" sz="2800" dirty="0"/>
          </a:p>
        </p:txBody>
      </p:sp>
    </p:spTree>
    <p:extLst>
      <p:ext uri="{BB962C8B-B14F-4D97-AF65-F5344CB8AC3E}">
        <p14:creationId xmlns:p14="http://schemas.microsoft.com/office/powerpoint/2010/main" val="291224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9A0C7F15-16A8-5A1A-FCDC-C4760FBA54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4860" y="37947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14E7BE8D-5342-0A6D-511E-EBA4FB8BA3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4660" y="37947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, line chart, scatter chart&#10;&#10;Description automatically generated">
            <a:extLst>
              <a:ext uri="{FF2B5EF4-FFF2-40B4-BE49-F238E27FC236}">
                <a16:creationId xmlns:a16="http://schemas.microsoft.com/office/drawing/2014/main" id="{DEAC9A10-0EEB-6A03-CFCC-15C64DAD8C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" y="14325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A703F58A-FA20-26B4-DAD0-F2E2467406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2680" y="14325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line chart&#10;&#10;Description automatically generated">
            <a:extLst>
              <a:ext uri="{FF2B5EF4-FFF2-40B4-BE49-F238E27FC236}">
                <a16:creationId xmlns:a16="http://schemas.microsoft.com/office/drawing/2014/main" id="{4EB1C2BA-C72C-1D9C-C004-A2748D1E792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4860" y="14325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4EC96CB7-B9FA-84D2-8F1D-E1976535B46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7040" y="14325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E823747D-0B89-FC53-99B1-5A35A217899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" y="37947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Chart, line chart&#10;&#10;Description automatically generated">
            <a:extLst>
              <a:ext uri="{FF2B5EF4-FFF2-40B4-BE49-F238E27FC236}">
                <a16:creationId xmlns:a16="http://schemas.microsoft.com/office/drawing/2014/main" id="{75772DA7-5E60-1718-E6C1-7251C28BD84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2680" y="37947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3039666D-E611-BFD5-FCC4-8FCFDEB7C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3538" y="487047"/>
            <a:ext cx="8492563" cy="72453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800" dirty="0"/>
              <a:t>Q-Q plots for days to heading based on SABWGPYT panels at </a:t>
            </a:r>
            <a:r>
              <a:rPr lang="en-US" sz="2800" dirty="0" err="1"/>
              <a:t>Pusa</a:t>
            </a:r>
            <a:endParaRPr lang="en-IN" sz="2800" dirty="0"/>
          </a:p>
        </p:txBody>
      </p:sp>
    </p:spTree>
    <p:extLst>
      <p:ext uri="{BB962C8B-B14F-4D97-AF65-F5344CB8AC3E}">
        <p14:creationId xmlns:p14="http://schemas.microsoft.com/office/powerpoint/2010/main" val="30184056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A447C0F4-8D7C-B9D1-D174-75A7594042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1797" y="3870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3D77BCCB-BEF5-934B-0770-9C66F1BEA1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97" y="1584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, line chart&#10;&#10;Description automatically generated">
            <a:extLst>
              <a:ext uri="{FF2B5EF4-FFF2-40B4-BE49-F238E27FC236}">
                <a16:creationId xmlns:a16="http://schemas.microsoft.com/office/drawing/2014/main" id="{90051053-9E0E-6637-405D-34551019C7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4037" y="1584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9AC82C32-253F-6CA1-EB11-FB0C6436276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227" y="1584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line chart&#10;&#10;Description automatically generated">
            <a:extLst>
              <a:ext uri="{FF2B5EF4-FFF2-40B4-BE49-F238E27FC236}">
                <a16:creationId xmlns:a16="http://schemas.microsoft.com/office/drawing/2014/main" id="{150E301F-8AC2-EA29-32BE-392D8148BBC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037" y="1584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E63D7577-C8EC-4E64-0BA5-C90407C59C7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97" y="3870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30E65710-5F4A-A7B1-1A86-CBC51358A61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9137" y="3870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Chart, line chart, histogram&#10;&#10;Description automatically generated">
            <a:extLst>
              <a:ext uri="{FF2B5EF4-FFF2-40B4-BE49-F238E27FC236}">
                <a16:creationId xmlns:a16="http://schemas.microsoft.com/office/drawing/2014/main" id="{BB50153C-1CE5-0754-C11F-0B0424B7EAC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9277" y="387096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FF663ABA-2620-B9DA-41EF-9F51F4148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997" y="456567"/>
            <a:ext cx="8557260" cy="72453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800" dirty="0"/>
              <a:t>Q-Q plots for days to maturity based on SABWGPYT panels at Jabalpur</a:t>
            </a:r>
            <a:endParaRPr lang="en-IN" sz="2800" dirty="0"/>
          </a:p>
        </p:txBody>
      </p:sp>
    </p:spTree>
    <p:extLst>
      <p:ext uri="{BB962C8B-B14F-4D97-AF65-F5344CB8AC3E}">
        <p14:creationId xmlns:p14="http://schemas.microsoft.com/office/powerpoint/2010/main" val="17575781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45F3E03F-5032-B8BC-D4A4-F506F1D56E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480" y="410718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DF65D1EE-19C8-D3C9-7247-80F8DD11A8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3900" y="410718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, line chart&#10;&#10;Description automatically generated">
            <a:extLst>
              <a:ext uri="{FF2B5EF4-FFF2-40B4-BE49-F238E27FC236}">
                <a16:creationId xmlns:a16="http://schemas.microsoft.com/office/drawing/2014/main" id="{7A562B58-41CF-AB87-4003-4FEE0ABD43F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5340" y="410718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2D1B819A-9BFA-181F-1D4E-B0460EE2497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3030" y="410718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line chart&#10;&#10;Description automatically generated">
            <a:extLst>
              <a:ext uri="{FF2B5EF4-FFF2-40B4-BE49-F238E27FC236}">
                <a16:creationId xmlns:a16="http://schemas.microsoft.com/office/drawing/2014/main" id="{637C3A90-74AA-6546-7716-4117C13774E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480" y="176022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B5386099-6DB6-EE78-66B1-E6925E129D7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5330" y="176022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D825D69C-F55A-4A57-1504-AC7679A058D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4180" y="176022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Chart, line chart&#10;&#10;Description automatically generated">
            <a:extLst>
              <a:ext uri="{FF2B5EF4-FFF2-40B4-BE49-F238E27FC236}">
                <a16:creationId xmlns:a16="http://schemas.microsoft.com/office/drawing/2014/main" id="{6E3F1E54-8D3F-5B0D-B10A-9985B33B796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3030" y="176022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B0FE7F2D-F908-B1F1-F54C-0ECBCC686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997" y="456567"/>
            <a:ext cx="8557260" cy="72453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800" dirty="0"/>
              <a:t>Q-Q plots for days to maturity based on SABWGPYT panels at Ludhiana</a:t>
            </a:r>
            <a:endParaRPr lang="en-IN" sz="2800" dirty="0"/>
          </a:p>
        </p:txBody>
      </p:sp>
    </p:spTree>
    <p:extLst>
      <p:ext uri="{BB962C8B-B14F-4D97-AF65-F5344CB8AC3E}">
        <p14:creationId xmlns:p14="http://schemas.microsoft.com/office/powerpoint/2010/main" val="1091847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line chart&#10;&#10;Description automatically generated">
            <a:extLst>
              <a:ext uri="{FF2B5EF4-FFF2-40B4-BE49-F238E27FC236}">
                <a16:creationId xmlns:a16="http://schemas.microsoft.com/office/drawing/2014/main" id="{FFA28B7F-8007-2094-F0C0-B3B7313D93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960" y="15621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Chart, line chart&#10;&#10;Description automatically generated">
            <a:extLst>
              <a:ext uri="{FF2B5EF4-FFF2-40B4-BE49-F238E27FC236}">
                <a16:creationId xmlns:a16="http://schemas.microsoft.com/office/drawing/2014/main" id="{4B9C2904-F10F-7A22-12A1-17A9C8EA9F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5620" y="15570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, line chart&#10;&#10;Description automatically generated">
            <a:extLst>
              <a:ext uri="{FF2B5EF4-FFF2-40B4-BE49-F238E27FC236}">
                <a16:creationId xmlns:a16="http://schemas.microsoft.com/office/drawing/2014/main" id="{11559185-84BF-03D7-96F8-3A35CD1101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3775711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6CD9CF37-FFF8-16E8-B37B-E51366C52FE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0300" y="3775711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hart, line chart&#10;&#10;Description automatically generated">
            <a:extLst>
              <a:ext uri="{FF2B5EF4-FFF2-40B4-BE49-F238E27FC236}">
                <a16:creationId xmlns:a16="http://schemas.microsoft.com/office/drawing/2014/main" id="{D0302522-B783-DE52-8507-277F2357B41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9420" y="3775711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Chart, line chart&#10;&#10;Description automatically generated">
            <a:extLst>
              <a:ext uri="{FF2B5EF4-FFF2-40B4-BE49-F238E27FC236}">
                <a16:creationId xmlns:a16="http://schemas.microsoft.com/office/drawing/2014/main" id="{0835BD1C-5A3D-41FD-A86D-BA9BBF4E2D8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6160" y="3775711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Chart, line chart&#10;&#10;Description automatically generated">
            <a:extLst>
              <a:ext uri="{FF2B5EF4-FFF2-40B4-BE49-F238E27FC236}">
                <a16:creationId xmlns:a16="http://schemas.microsoft.com/office/drawing/2014/main" id="{35224897-9AE0-4D0B-AEDD-542269DA4A0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15621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Chart, line chart&#10;&#10;Description automatically generated">
            <a:extLst>
              <a:ext uri="{FF2B5EF4-FFF2-40B4-BE49-F238E27FC236}">
                <a16:creationId xmlns:a16="http://schemas.microsoft.com/office/drawing/2014/main" id="{C4C91991-A4EE-FFCF-14C7-580F9A4563D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0300" y="1562100"/>
            <a:ext cx="2160000" cy="21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0F19F7C0-E79E-0736-0942-325A2D0DCB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8997" y="456567"/>
            <a:ext cx="8557260" cy="72453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2800" dirty="0"/>
              <a:t>Q-Q plots for days to maturity based on SABWGPYT panels at </a:t>
            </a:r>
            <a:r>
              <a:rPr lang="en-US" sz="2800" dirty="0" err="1"/>
              <a:t>Pusa</a:t>
            </a:r>
            <a:endParaRPr lang="en-IN" sz="2800" dirty="0"/>
          </a:p>
        </p:txBody>
      </p:sp>
    </p:spTree>
    <p:extLst>
      <p:ext uri="{BB962C8B-B14F-4D97-AF65-F5344CB8AC3E}">
        <p14:creationId xmlns:p14="http://schemas.microsoft.com/office/powerpoint/2010/main" val="245550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72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Q-Q plots for days to heading based on SABWGPYT panels at Jabalpur</vt:lpstr>
      <vt:lpstr>Q-Q plots for days to heading based on SABWGPYT panels at Ludhiana</vt:lpstr>
      <vt:lpstr>Q-Q plots for days to heading based on SABWGPYT panels at Pusa</vt:lpstr>
      <vt:lpstr>Q-Q plots for days to maturity based on SABWGPYT panels at Jabalpur</vt:lpstr>
      <vt:lpstr>Q-Q plots for days to maturity based on SABWGPYT panels at Ludhiana</vt:lpstr>
      <vt:lpstr>Q-Q plots for days to maturity based on SABWGPYT panels at Pus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-Q plots for days to heading based on SABWGPYT panels at Jabalpur</dc:title>
  <dc:creator>KUMAR, Uttam (CIMMYT-India)</dc:creator>
  <cp:lastModifiedBy>KUMAR, Uttam (CIMMYT-India)</cp:lastModifiedBy>
  <cp:revision>1</cp:revision>
  <dcterms:created xsi:type="dcterms:W3CDTF">2022-06-02T07:06:55Z</dcterms:created>
  <dcterms:modified xsi:type="dcterms:W3CDTF">2022-06-02T07:59:58Z</dcterms:modified>
</cp:coreProperties>
</file>